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7177D7-D015-2BF4-43FC-980A59ECAF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FDA8768-7944-0A51-3AE3-F4CE5ADF1A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687D8B-19AA-6B76-50D9-2CAC2CCE3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C5460F-80EB-212A-3287-09E0CF9DA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579202-64A0-26C5-8C2A-65B85EE07D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37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07393C-CB90-7030-49B9-B6AEC77CFD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15E274D-87E9-2210-02EA-30579BE6D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105185-BA44-EE1B-595E-4EF8E1767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E5D711-ED81-C015-410A-C8BCD1967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0D054D-5251-FE56-C58A-FA170F3A8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79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8EB1522-F400-4557-9257-714109436E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D6F7E2B-4553-ECED-7A19-902E390101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8B13E2-1762-CC39-BDEA-60055DE34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50EA0E-0AFF-9ADC-E71C-0A22BA5CE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204307-53AA-C28B-F461-93A02F612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574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6E15CA-7393-9CBA-E809-3CE65C944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5F4E4A-0C8A-6011-CB9F-041E585A1B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F313693-5A4A-8E3B-D4EC-80FF5C7E0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5EDEED-A340-69CB-5627-3AB228274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461EAEA-FE21-D409-01A7-FD8227CA6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62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D12C78-8B64-2340-CF9C-C01A678B7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5894E3-F4F2-629E-07A2-D45E0B5663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259E10-84C0-F7F0-EFAE-A27B2C5AB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A2DB54-6881-5D05-B6C2-596134B21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E310F3-CFF0-22ED-530C-7794CC3D0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4315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D39912-ACEA-3247-F7C1-B56748F37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831FC6-AD21-04EC-6055-4CCA01CDFC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B4CBB90-DB0D-0F1A-52CA-3A365929EC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AF5D469-83FD-58FB-9192-C44C62171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F3B1CBC-D1C0-BE15-59B3-8F93664ED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E9B058-BC38-2F3C-7A9E-CD438A8D4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905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DEB585-2BF5-B77A-9272-7FF603B371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57CCD2-1C21-DA72-65D6-7E4EC26258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110559-6FBC-8D07-4F56-984C9E20B3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579FFDA-CE6B-6BE2-35AD-F2ABEF5E65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36F1EA-8AC8-CB4E-92FD-66B11E491D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7ED7377-55E4-B41D-8418-2A57E784B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056CDAE-2FE5-B426-DACD-C5F376176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417E63C-3288-B1D7-D274-BDC0DDDE2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2216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80B50B-C778-7228-990E-276185F97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BCEC495-A15C-D225-C799-E2AFFE43E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E505D4C-B68A-8B13-3AA6-F06305AF7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07C771-17A7-8807-9012-B72BB121F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3743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C01687D-5D4E-A944-C234-312C11FCF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978147D-BFFE-52EF-F5F2-5565C4A34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5039EE1-3560-0C1D-EF63-53D8BB1B1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860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ED3993-A0EF-4CEE-0E15-215269480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FABCB68-8E98-11F6-D8BD-E63A48E6B5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EF5FB4-A382-4B94-65B7-BB663F5CE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1EF5FDB-9F14-4D84-CAE9-6D5D2AFCC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A72C8B-4D3B-4BB2-4F9F-94BC71D4C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C1FB2F-231F-178D-C2EC-156D21CDA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941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67A06D-FB10-2FE7-6024-C98C3945C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251DFC0-DD37-8B85-015E-20F1ABDDAF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04C3F07-9269-D777-40EA-E316957D3F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25956E6-49B9-09EF-EB4A-F3A8800F4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D84F99-B63D-5DE3-7BFA-53EA4DD2E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949996-7347-FAAC-45B3-4541052DB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47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B40AEA2-4E01-B659-2889-279061C20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DA441E3-4FFE-C1FA-57C5-8CF985837B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8929B0-5C12-DCE1-20B6-4BEFA7FCBA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E9802F-2AE2-445E-8548-8B096B2A327F}" type="datetimeFigureOut">
              <a:rPr kumimoji="1" lang="ja-JP" altLang="en-US" smtClean="0"/>
              <a:t>2025/3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AFD997-650C-0BF6-588A-4D6D5D981B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AC9763-DF99-0376-CABA-E0FB114C59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51A37F-E0E0-4ACE-AB91-D8CB1ED515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385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8">
            <a:extLst>
              <a:ext uri="{FF2B5EF4-FFF2-40B4-BE49-F238E27FC236}">
                <a16:creationId xmlns:a16="http://schemas.microsoft.com/office/drawing/2014/main" id="{37971FF6-3E44-B4AF-B4A3-2278EDF483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85" t="14734" r="24808" b="29435"/>
          <a:stretch/>
        </p:blipFill>
        <p:spPr>
          <a:xfrm>
            <a:off x="7265325" y="728669"/>
            <a:ext cx="4405743" cy="420679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68B98CB-32A6-0A8A-DD49-2531ACD312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32" t="14993" r="25017" b="28888"/>
          <a:stretch/>
        </p:blipFill>
        <p:spPr>
          <a:xfrm>
            <a:off x="1196103" y="730607"/>
            <a:ext cx="4367045" cy="420485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0E0C39-E15B-A804-2985-87AE4855BE95}"/>
              </a:ext>
            </a:extLst>
          </p:cNvPr>
          <p:cNvSpPr txBox="1"/>
          <p:nvPr/>
        </p:nvSpPr>
        <p:spPr>
          <a:xfrm>
            <a:off x="76840" y="122945"/>
            <a:ext cx="30125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ly Figure S1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F566759-645B-C2ED-0577-60BDC7EDB123}"/>
              </a:ext>
            </a:extLst>
          </p:cNvPr>
          <p:cNvSpPr txBox="1"/>
          <p:nvPr/>
        </p:nvSpPr>
        <p:spPr>
          <a:xfrm>
            <a:off x="520932" y="637401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1FA28EF-CA3B-FC31-5037-EC122D746C29}"/>
              </a:ext>
            </a:extLst>
          </p:cNvPr>
          <p:cNvSpPr txBox="1"/>
          <p:nvPr/>
        </p:nvSpPr>
        <p:spPr>
          <a:xfrm>
            <a:off x="6731295" y="545941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F2C6D33-AE2E-9FF0-8E9A-B8F2B2D54EB7}"/>
              </a:ext>
            </a:extLst>
          </p:cNvPr>
          <p:cNvSpPr txBox="1"/>
          <p:nvPr/>
        </p:nvSpPr>
        <p:spPr>
          <a:xfrm>
            <a:off x="391886" y="5574268"/>
            <a:ext cx="11279182" cy="70788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Cross-sectional images of a thigh MRI of a patient with SMA. A) Example of T1-weighted image used to determine the periphery of each muscle, B) muscle and fat segmentation in the cross-sectional image.</a:t>
            </a:r>
          </a:p>
        </p:txBody>
      </p:sp>
    </p:spTree>
    <p:extLst>
      <p:ext uri="{BB962C8B-B14F-4D97-AF65-F5344CB8AC3E}">
        <p14:creationId xmlns:p14="http://schemas.microsoft.com/office/powerpoint/2010/main" val="1791032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C4E9272-2FC8-42FE-3CE6-096430E4E1EF}"/>
              </a:ext>
            </a:extLst>
          </p:cNvPr>
          <p:cNvSpPr txBox="1"/>
          <p:nvPr/>
        </p:nvSpPr>
        <p:spPr>
          <a:xfrm>
            <a:off x="824592" y="163767"/>
            <a:ext cx="10393137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Table S1</a:t>
            </a:r>
            <a:r>
              <a:rPr lang="en-US" altLang="ja-JP" sz="2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Correlation between body mass index, lipid metabolism and intramuscular fatty fraction in different muscle groups</a:t>
            </a:r>
            <a:endParaRPr lang="ja-JP" altLang="ja-JP" sz="2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905E018B-1025-5503-B211-457B88F418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3312743"/>
              </p:ext>
            </p:extLst>
          </p:nvPr>
        </p:nvGraphicFramePr>
        <p:xfrm>
          <a:off x="889906" y="1151165"/>
          <a:ext cx="9691006" cy="2379742"/>
        </p:xfrm>
        <a:graphic>
          <a:graphicData uri="http://schemas.openxmlformats.org/drawingml/2006/table">
            <a:tbl>
              <a:tblPr firstCol="1">
                <a:tableStyleId>{5C22544A-7EE6-4342-B048-85BDC9FD1C3A}</a:tableStyleId>
              </a:tblPr>
              <a:tblGrid>
                <a:gridCol w="2424463">
                  <a:extLst>
                    <a:ext uri="{9D8B030D-6E8A-4147-A177-3AD203B41FA5}">
                      <a16:colId xmlns:a16="http://schemas.microsoft.com/office/drawing/2014/main" val="2327146387"/>
                    </a:ext>
                  </a:extLst>
                </a:gridCol>
                <a:gridCol w="2422181">
                  <a:extLst>
                    <a:ext uri="{9D8B030D-6E8A-4147-A177-3AD203B41FA5}">
                      <a16:colId xmlns:a16="http://schemas.microsoft.com/office/drawing/2014/main" val="2733830319"/>
                    </a:ext>
                  </a:extLst>
                </a:gridCol>
                <a:gridCol w="2422181">
                  <a:extLst>
                    <a:ext uri="{9D8B030D-6E8A-4147-A177-3AD203B41FA5}">
                      <a16:colId xmlns:a16="http://schemas.microsoft.com/office/drawing/2014/main" val="4136766594"/>
                    </a:ext>
                  </a:extLst>
                </a:gridCol>
                <a:gridCol w="2422181">
                  <a:extLst>
                    <a:ext uri="{9D8B030D-6E8A-4147-A177-3AD203B41FA5}">
                      <a16:colId xmlns:a16="http://schemas.microsoft.com/office/drawing/2014/main" val="2084892950"/>
                    </a:ext>
                  </a:extLst>
                </a:gridCol>
              </a:tblGrid>
              <a:tr h="79193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I-SDS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cholesterol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0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glyceride</a:t>
                      </a:r>
                      <a:endParaRPr lang="ja-JP" sz="20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2302187"/>
                  </a:ext>
                </a:extLst>
              </a:tr>
              <a:tr h="52926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driceps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ja-JP" sz="2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141850"/>
                  </a:ext>
                </a:extLst>
              </a:tr>
              <a:tr h="52926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ductors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ja-JP" sz="2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6255289"/>
                  </a:ext>
                </a:extLst>
              </a:tr>
              <a:tr h="52926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mstrings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ja-JP" sz="2400" b="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－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ja-JP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</a:t>
                      </a:r>
                      <a:r>
                        <a:rPr lang="en-US" sz="2400" b="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ja-JP" sz="2400" b="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2335652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76FBA7A-8E98-2DC2-8785-79BE3DCF98A4}"/>
              </a:ext>
            </a:extLst>
          </p:cNvPr>
          <p:cNvSpPr txBox="1"/>
          <p:nvPr/>
        </p:nvSpPr>
        <p:spPr>
          <a:xfrm>
            <a:off x="5512934" y="3652549"/>
            <a:ext cx="609463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MI: body mass index, SDS: standard deviation score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34008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7</TotalTime>
  <Words>104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粟野　宏之</dc:creator>
  <cp:lastModifiedBy>MDPI</cp:lastModifiedBy>
  <cp:revision>20</cp:revision>
  <dcterms:created xsi:type="dcterms:W3CDTF">2024-12-08T03:41:16Z</dcterms:created>
  <dcterms:modified xsi:type="dcterms:W3CDTF">2025-03-17T14:05:25Z</dcterms:modified>
</cp:coreProperties>
</file>